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5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00CC"/>
    <a:srgbClr val="1C1C1C"/>
    <a:srgbClr val="F2F2F2"/>
    <a:srgbClr val="E8E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160" autoAdjust="0"/>
    <p:restoredTop sz="89627" autoAdjust="0"/>
  </p:normalViewPr>
  <p:slideViewPr>
    <p:cSldViewPr snapToGrid="0" showGuides="1">
      <p:cViewPr>
        <p:scale>
          <a:sx n="80" d="100"/>
          <a:sy n="80" d="100"/>
        </p:scale>
        <p:origin x="3516" y="-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832191-5C7A-488A-945F-E73710EE460B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1" y="4473580"/>
            <a:ext cx="548640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8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8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43C719-F9F6-4564-BF51-D6F285A3FB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97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7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71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382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901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036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535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084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872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509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278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180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23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8966E5BF-0E42-5CE7-8C21-700AA1CEFCDE}"/>
              </a:ext>
            </a:extLst>
          </p:cNvPr>
          <p:cNvGrpSpPr/>
          <p:nvPr/>
        </p:nvGrpSpPr>
        <p:grpSpPr>
          <a:xfrm>
            <a:off x="127259" y="786572"/>
            <a:ext cx="6564571" cy="7357978"/>
            <a:chOff x="22847" y="921427"/>
            <a:chExt cx="6829885" cy="761724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C02566B-67CD-0E9D-0A99-BB6A03E0E64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110" y="1072897"/>
              <a:ext cx="6660000" cy="726402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67B8518-7CF8-B3DA-0B7A-F6D5E1FE7C70}"/>
                </a:ext>
              </a:extLst>
            </p:cNvPr>
            <p:cNvSpPr txBox="1"/>
            <p:nvPr/>
          </p:nvSpPr>
          <p:spPr>
            <a:xfrm>
              <a:off x="236135" y="921427"/>
              <a:ext cx="468982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ungated</a:t>
              </a:r>
              <a:endParaRPr lang="en-US" sz="600" b="1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39400DC-59FD-8A2B-81E1-F855DCCF68BC}"/>
                </a:ext>
              </a:extLst>
            </p:cNvPr>
            <p:cNvSpPr txBox="1"/>
            <p:nvPr/>
          </p:nvSpPr>
          <p:spPr>
            <a:xfrm>
              <a:off x="649903" y="2160433"/>
              <a:ext cx="34056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time</a:t>
              </a:r>
              <a:endParaRPr lang="en-US" sz="6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113306C-2D83-6485-DEC9-8BA73D340051}"/>
                </a:ext>
              </a:extLst>
            </p:cNvPr>
            <p:cNvSpPr txBox="1"/>
            <p:nvPr/>
          </p:nvSpPr>
          <p:spPr>
            <a:xfrm rot="16200000">
              <a:off x="-78683" y="1594610"/>
              <a:ext cx="403587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SSC-W</a:t>
              </a:r>
              <a:endParaRPr lang="en-US" sz="60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918B71F-4056-A945-D1C1-43492237FA16}"/>
                </a:ext>
              </a:extLst>
            </p:cNvPr>
            <p:cNvSpPr txBox="1"/>
            <p:nvPr/>
          </p:nvSpPr>
          <p:spPr>
            <a:xfrm rot="16200000">
              <a:off x="1327338" y="1594610"/>
              <a:ext cx="382015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SSC-H</a:t>
              </a:r>
              <a:endParaRPr lang="en-US" sz="60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6511656-3D74-DDC5-67B3-B11CF461992D}"/>
                </a:ext>
              </a:extLst>
            </p:cNvPr>
            <p:cNvSpPr txBox="1"/>
            <p:nvPr/>
          </p:nvSpPr>
          <p:spPr>
            <a:xfrm rot="16200000">
              <a:off x="2664133" y="1594610"/>
              <a:ext cx="403587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SSC-W</a:t>
              </a:r>
              <a:endParaRPr lang="en-US" sz="60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654AFE8-6086-9E78-718F-8DF44D44F480}"/>
                </a:ext>
              </a:extLst>
            </p:cNvPr>
            <p:cNvSpPr txBox="1"/>
            <p:nvPr/>
          </p:nvSpPr>
          <p:spPr>
            <a:xfrm rot="16200000">
              <a:off x="4044036" y="1594610"/>
              <a:ext cx="382015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FSC-H</a:t>
              </a:r>
              <a:endParaRPr lang="en-US" sz="60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2647F77-FE05-4A1C-125B-ABD965B465BE}"/>
                </a:ext>
              </a:extLst>
            </p:cNvPr>
            <p:cNvSpPr txBox="1"/>
            <p:nvPr/>
          </p:nvSpPr>
          <p:spPr>
            <a:xfrm rot="16200000">
              <a:off x="5286973" y="1594610"/>
              <a:ext cx="639235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FVD-eF455UV</a:t>
              </a:r>
              <a:endParaRPr lang="en-US" sz="60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D54CBFC-443C-F112-5DE5-C54246850DF3}"/>
                </a:ext>
              </a:extLst>
            </p:cNvPr>
            <p:cNvSpPr txBox="1"/>
            <p:nvPr/>
          </p:nvSpPr>
          <p:spPr>
            <a:xfrm>
              <a:off x="2006611" y="2160433"/>
              <a:ext cx="38392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FSC-H</a:t>
              </a:r>
              <a:endParaRPr lang="en-US" sz="6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FB26002-7194-AD6F-6EA2-B6FBD9310607}"/>
                </a:ext>
              </a:extLst>
            </p:cNvPr>
            <p:cNvSpPr txBox="1"/>
            <p:nvPr/>
          </p:nvSpPr>
          <p:spPr>
            <a:xfrm>
              <a:off x="3376880" y="2160432"/>
              <a:ext cx="38392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FSC-H</a:t>
              </a:r>
              <a:endParaRPr lang="en-US" sz="6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CA367FA-55C9-2117-D4A8-8F388713984A}"/>
                </a:ext>
              </a:extLst>
            </p:cNvPr>
            <p:cNvSpPr txBox="1"/>
            <p:nvPr/>
          </p:nvSpPr>
          <p:spPr>
            <a:xfrm>
              <a:off x="4669125" y="2160432"/>
              <a:ext cx="380590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FSC-A</a:t>
              </a:r>
              <a:endParaRPr lang="en-US" sz="60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665BF0E-449E-1742-A7D1-887F86A98808}"/>
                </a:ext>
              </a:extLst>
            </p:cNvPr>
            <p:cNvSpPr txBox="1"/>
            <p:nvPr/>
          </p:nvSpPr>
          <p:spPr>
            <a:xfrm>
              <a:off x="6051061" y="2160432"/>
              <a:ext cx="380590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FSC-A</a:t>
              </a:r>
              <a:endParaRPr lang="en-US" sz="60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59EFDF9-E624-DE82-6653-AC7990D26307}"/>
                </a:ext>
              </a:extLst>
            </p:cNvPr>
            <p:cNvSpPr txBox="1"/>
            <p:nvPr/>
          </p:nvSpPr>
          <p:spPr>
            <a:xfrm>
              <a:off x="497669" y="3633601"/>
              <a:ext cx="529023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45-FITC</a:t>
              </a:r>
              <a:endParaRPr lang="en-US" sz="600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9C9A476-F38C-FD5B-90BB-CACE4637D7F3}"/>
                </a:ext>
              </a:extLst>
            </p:cNvPr>
            <p:cNvSpPr txBox="1"/>
            <p:nvPr/>
          </p:nvSpPr>
          <p:spPr>
            <a:xfrm rot="16200000">
              <a:off x="-207294" y="3009037"/>
              <a:ext cx="660808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EpCAM-BV480</a:t>
              </a:r>
              <a:endParaRPr lang="en-US" sz="60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14441A4-1B32-7E39-34C2-1BB5B5A8B8CC}"/>
                </a:ext>
              </a:extLst>
            </p:cNvPr>
            <p:cNvSpPr txBox="1"/>
            <p:nvPr/>
          </p:nvSpPr>
          <p:spPr>
            <a:xfrm rot="16200000">
              <a:off x="1173836" y="2971133"/>
              <a:ext cx="689019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49f-APC-Cy7</a:t>
              </a:r>
              <a:endParaRPr lang="en-US" sz="60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850FCF4-A255-62C1-CA77-1CF89D913358}"/>
                </a:ext>
              </a:extLst>
            </p:cNvPr>
            <p:cNvSpPr txBox="1"/>
            <p:nvPr/>
          </p:nvSpPr>
          <p:spPr>
            <a:xfrm rot="16200000">
              <a:off x="2542160" y="2971133"/>
              <a:ext cx="647532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90-BUV615</a:t>
              </a:r>
              <a:endParaRPr lang="en-US" sz="60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3EC44D2-ECCA-3B08-BBCC-E4A19A337545}"/>
                </a:ext>
              </a:extLst>
            </p:cNvPr>
            <p:cNvSpPr txBox="1"/>
            <p:nvPr/>
          </p:nvSpPr>
          <p:spPr>
            <a:xfrm rot="16200000">
              <a:off x="3890535" y="2971133"/>
              <a:ext cx="689019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49f-APC-Cy7</a:t>
              </a:r>
              <a:endParaRPr lang="en-US" sz="60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E541CA3-5B3D-9813-6054-0830F453D629}"/>
                </a:ext>
              </a:extLst>
            </p:cNvPr>
            <p:cNvSpPr txBox="1"/>
            <p:nvPr/>
          </p:nvSpPr>
          <p:spPr>
            <a:xfrm rot="16200000">
              <a:off x="-64976" y="4525241"/>
              <a:ext cx="382015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SSC-H</a:t>
              </a:r>
              <a:endParaRPr lang="en-US" sz="60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95BEBAB-1F80-3427-AC60-0794F5F9DE51}"/>
                </a:ext>
              </a:extLst>
            </p:cNvPr>
            <p:cNvSpPr txBox="1"/>
            <p:nvPr/>
          </p:nvSpPr>
          <p:spPr>
            <a:xfrm>
              <a:off x="1840547" y="3633601"/>
              <a:ext cx="650772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31-BUV805</a:t>
              </a:r>
              <a:endParaRPr lang="en-US" sz="6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33222C3-7A84-7776-B3FD-261FE4BB9044}"/>
                </a:ext>
              </a:extLst>
            </p:cNvPr>
            <p:cNvSpPr txBox="1"/>
            <p:nvPr/>
          </p:nvSpPr>
          <p:spPr>
            <a:xfrm>
              <a:off x="3242942" y="3633600"/>
              <a:ext cx="57405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Sca1-BV711</a:t>
              </a:r>
              <a:endParaRPr lang="en-US" sz="6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DBAB41D-896B-2870-089E-8486A63DEBFF}"/>
                </a:ext>
              </a:extLst>
            </p:cNvPr>
            <p:cNvSpPr txBox="1"/>
            <p:nvPr/>
          </p:nvSpPr>
          <p:spPr>
            <a:xfrm>
              <a:off x="4593664" y="3633600"/>
              <a:ext cx="650772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24-BUV563</a:t>
              </a:r>
              <a:endParaRPr lang="en-US" sz="6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BC43423-AA0E-0492-3EDD-1DD4BC0E7F3B}"/>
                </a:ext>
              </a:extLst>
            </p:cNvPr>
            <p:cNvSpPr txBox="1"/>
            <p:nvPr/>
          </p:nvSpPr>
          <p:spPr>
            <a:xfrm>
              <a:off x="458372" y="5155501"/>
              <a:ext cx="59907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19-BV510</a:t>
              </a:r>
              <a:endParaRPr lang="en-US" sz="60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25E0EEE-1C1F-011F-3F3C-0D9769B8ADAF}"/>
                </a:ext>
              </a:extLst>
            </p:cNvPr>
            <p:cNvSpPr txBox="1"/>
            <p:nvPr/>
          </p:nvSpPr>
          <p:spPr>
            <a:xfrm>
              <a:off x="1838073" y="5162127"/>
              <a:ext cx="684128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11c-BUV737</a:t>
              </a:r>
              <a:endParaRPr lang="en-US" sz="6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0D5BFF4-CCC1-07DF-800F-3ECA7DE126BE}"/>
                </a:ext>
              </a:extLst>
            </p:cNvPr>
            <p:cNvSpPr txBox="1"/>
            <p:nvPr/>
          </p:nvSpPr>
          <p:spPr>
            <a:xfrm rot="16200000">
              <a:off x="1207027" y="4525241"/>
              <a:ext cx="622640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HCII-BB630</a:t>
              </a:r>
              <a:endParaRPr lang="en-US" sz="60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8E357A2-6106-4105-D5BE-2DEF9B536B95}"/>
                </a:ext>
              </a:extLst>
            </p:cNvPr>
            <p:cNvSpPr txBox="1"/>
            <p:nvPr/>
          </p:nvSpPr>
          <p:spPr>
            <a:xfrm rot="16200000">
              <a:off x="2525565" y="4525241"/>
              <a:ext cx="680722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11c-BUV737</a:t>
              </a:r>
              <a:endParaRPr lang="en-US" sz="60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62EDE85-52C3-B408-9346-49225CEE8BC2}"/>
                </a:ext>
              </a:extLst>
            </p:cNvPr>
            <p:cNvSpPr txBox="1"/>
            <p:nvPr/>
          </p:nvSpPr>
          <p:spPr>
            <a:xfrm rot="16200000">
              <a:off x="3943639" y="4525241"/>
              <a:ext cx="582812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Ly6G-BV785</a:t>
              </a:r>
              <a:endParaRPr lang="en-US" sz="60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41F5462-3336-2BE0-8C68-D2307C78E4B5}"/>
                </a:ext>
              </a:extLst>
            </p:cNvPr>
            <p:cNvSpPr txBox="1"/>
            <p:nvPr/>
          </p:nvSpPr>
          <p:spPr>
            <a:xfrm rot="16200000">
              <a:off x="5320992" y="4525241"/>
              <a:ext cx="571196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Ly6C-AF700</a:t>
              </a:r>
              <a:endParaRPr lang="en-US" sz="60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DD1EFE5-C229-D217-77A2-EDFADA5774FE}"/>
                </a:ext>
              </a:extLst>
            </p:cNvPr>
            <p:cNvSpPr txBox="1"/>
            <p:nvPr/>
          </p:nvSpPr>
          <p:spPr>
            <a:xfrm rot="16200000">
              <a:off x="-277533" y="6082537"/>
              <a:ext cx="811821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F4/80-PEDazzle594</a:t>
              </a:r>
              <a:endParaRPr lang="en-US" sz="60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EF61C4F-2801-5B32-4EB3-0F35FC76A9F5}"/>
                </a:ext>
              </a:extLst>
            </p:cNvPr>
            <p:cNvSpPr txBox="1"/>
            <p:nvPr/>
          </p:nvSpPr>
          <p:spPr>
            <a:xfrm>
              <a:off x="3102299" y="5162127"/>
              <a:ext cx="83256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11b-PerCP-Cy5.5</a:t>
              </a:r>
              <a:endParaRPr lang="en-US" sz="6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D1BF042-E308-B4F5-8B2E-8494B99676B1}"/>
                </a:ext>
              </a:extLst>
            </p:cNvPr>
            <p:cNvSpPr txBox="1"/>
            <p:nvPr/>
          </p:nvSpPr>
          <p:spPr>
            <a:xfrm>
              <a:off x="4479176" y="5162127"/>
              <a:ext cx="83256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11b-PerCP-Cy5.5</a:t>
              </a:r>
              <a:endParaRPr lang="en-US" sz="6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4769D5B-AB5B-44A0-80F1-F601A40BEDF7}"/>
                </a:ext>
              </a:extLst>
            </p:cNvPr>
            <p:cNvSpPr txBox="1"/>
            <p:nvPr/>
          </p:nvSpPr>
          <p:spPr>
            <a:xfrm>
              <a:off x="5815052" y="5162127"/>
              <a:ext cx="83256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11b-PerCP-Cy5.5</a:t>
              </a:r>
              <a:endParaRPr lang="en-US" sz="6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4F2259B-7A06-CC1C-838A-EAE70B41BDFA}"/>
                </a:ext>
              </a:extLst>
            </p:cNvPr>
            <p:cNvSpPr txBox="1"/>
            <p:nvPr/>
          </p:nvSpPr>
          <p:spPr>
            <a:xfrm>
              <a:off x="368483" y="6719424"/>
              <a:ext cx="83256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11b-PerCP-Cy5.5</a:t>
              </a:r>
              <a:endParaRPr lang="en-US" sz="6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69B3B30-B7D1-95EA-D6C8-37F2B1FBCA7B}"/>
                </a:ext>
              </a:extLst>
            </p:cNvPr>
            <p:cNvSpPr txBox="1"/>
            <p:nvPr/>
          </p:nvSpPr>
          <p:spPr>
            <a:xfrm>
              <a:off x="1852306" y="6725843"/>
              <a:ext cx="639097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206-BV605</a:t>
              </a:r>
              <a:endParaRPr lang="en-US" sz="60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E3FD3E5-2861-FFA5-C659-A625A8DF300D}"/>
                </a:ext>
              </a:extLst>
            </p:cNvPr>
            <p:cNvSpPr txBox="1"/>
            <p:nvPr/>
          </p:nvSpPr>
          <p:spPr>
            <a:xfrm rot="16200000">
              <a:off x="1207027" y="6082537"/>
              <a:ext cx="622640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HCII-BB630</a:t>
              </a:r>
              <a:endParaRPr lang="en-US" sz="60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9FE96D4-5304-D356-79FD-3B85017DF805}"/>
                </a:ext>
              </a:extLst>
            </p:cNvPr>
            <p:cNvSpPr txBox="1"/>
            <p:nvPr/>
          </p:nvSpPr>
          <p:spPr>
            <a:xfrm rot="16200000">
              <a:off x="2554606" y="6082537"/>
              <a:ext cx="622640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HCII-BB630</a:t>
              </a:r>
              <a:endParaRPr lang="en-US" sz="60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042368C-CDDD-E0AC-94F9-D84B2DB1BA4B}"/>
                </a:ext>
              </a:extLst>
            </p:cNvPr>
            <p:cNvSpPr txBox="1"/>
            <p:nvPr/>
          </p:nvSpPr>
          <p:spPr>
            <a:xfrm rot="16200000">
              <a:off x="3906300" y="6082537"/>
              <a:ext cx="657489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Bst2-PE-eF610</a:t>
              </a:r>
              <a:endParaRPr lang="en-US" sz="60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F905DD6-0E8B-33DE-882C-140209ABAFB7}"/>
                </a:ext>
              </a:extLst>
            </p:cNvPr>
            <p:cNvSpPr txBox="1"/>
            <p:nvPr/>
          </p:nvSpPr>
          <p:spPr>
            <a:xfrm rot="16200000">
              <a:off x="5328460" y="6082537"/>
              <a:ext cx="556260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5-BV421</a:t>
              </a:r>
              <a:endParaRPr lang="en-US" sz="60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5F1F91B-B4AE-FFF6-D97F-4DE429B43698}"/>
                </a:ext>
              </a:extLst>
            </p:cNvPr>
            <p:cNvSpPr txBox="1"/>
            <p:nvPr/>
          </p:nvSpPr>
          <p:spPr>
            <a:xfrm rot="16200000">
              <a:off x="-176226" y="7646409"/>
              <a:ext cx="607704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8-BUV395</a:t>
              </a:r>
              <a:endParaRPr lang="en-US" sz="60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37E8DE6-A744-FB0D-2BB6-CDF1AE73B661}"/>
                </a:ext>
              </a:extLst>
            </p:cNvPr>
            <p:cNvSpPr txBox="1"/>
            <p:nvPr/>
          </p:nvSpPr>
          <p:spPr>
            <a:xfrm>
              <a:off x="3229412" y="6725843"/>
              <a:ext cx="59907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19-BV510</a:t>
              </a:r>
              <a:endParaRPr lang="en-US" sz="600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29D641E-2B0E-5955-953A-A37C2E2F10F4}"/>
                </a:ext>
              </a:extLst>
            </p:cNvPr>
            <p:cNvSpPr txBox="1"/>
            <p:nvPr/>
          </p:nvSpPr>
          <p:spPr>
            <a:xfrm>
              <a:off x="4644427" y="6725842"/>
              <a:ext cx="57405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Ly6C-AF700</a:t>
              </a:r>
              <a:endParaRPr lang="en-US" sz="600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D5A77B5-5E81-7A10-10F2-69966B1B5485}"/>
                </a:ext>
              </a:extLst>
            </p:cNvPr>
            <p:cNvSpPr txBox="1"/>
            <p:nvPr/>
          </p:nvSpPr>
          <p:spPr>
            <a:xfrm>
              <a:off x="6018202" y="6725842"/>
              <a:ext cx="428955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DX5-PE</a:t>
              </a:r>
              <a:endParaRPr lang="en-US" sz="60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A457B0C-2435-5990-B593-01A707C4494A}"/>
                </a:ext>
              </a:extLst>
            </p:cNvPr>
            <p:cNvSpPr txBox="1"/>
            <p:nvPr/>
          </p:nvSpPr>
          <p:spPr>
            <a:xfrm>
              <a:off x="511686" y="8294073"/>
              <a:ext cx="55904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4-BV650</a:t>
              </a:r>
              <a:endParaRPr lang="en-US" sz="600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50672E7-889C-223E-7F37-60BB856A8983}"/>
                </a:ext>
              </a:extLst>
            </p:cNvPr>
            <p:cNvSpPr txBox="1"/>
            <p:nvPr/>
          </p:nvSpPr>
          <p:spPr>
            <a:xfrm>
              <a:off x="1907754" y="8294073"/>
              <a:ext cx="55904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4-BV650</a:t>
              </a:r>
              <a:endParaRPr lang="en-US" sz="6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48FE328-8C8F-0EC5-927D-025892EE68BB}"/>
                </a:ext>
              </a:extLst>
            </p:cNvPr>
            <p:cNvSpPr txBox="1"/>
            <p:nvPr/>
          </p:nvSpPr>
          <p:spPr>
            <a:xfrm rot="16200000">
              <a:off x="1214494" y="7646409"/>
              <a:ext cx="607704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8-BUV395</a:t>
              </a:r>
              <a:endParaRPr lang="en-US" sz="60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CD6370C-A3FD-E513-8EC4-8F506E7BD6C1}"/>
                </a:ext>
              </a:extLst>
            </p:cNvPr>
            <p:cNvSpPr txBox="1"/>
            <p:nvPr/>
          </p:nvSpPr>
          <p:spPr>
            <a:xfrm rot="16200000">
              <a:off x="2559583" y="7646409"/>
              <a:ext cx="612683" cy="192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FoxP3-AF647</a:t>
              </a:r>
              <a:endParaRPr lang="en-US" sz="60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B248FF0-93CF-997A-2143-08F0F8779D37}"/>
                </a:ext>
              </a:extLst>
            </p:cNvPr>
            <p:cNvSpPr txBox="1"/>
            <p:nvPr/>
          </p:nvSpPr>
          <p:spPr>
            <a:xfrm>
              <a:off x="3221052" y="8294072"/>
              <a:ext cx="615748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dirty="0"/>
                <a:t>CD25-PE-Cy7</a:t>
              </a:r>
              <a:endParaRPr lang="en-US" sz="600" dirty="0"/>
            </a:p>
          </p:txBody>
        </p: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0B1AE509-F26D-2685-EBD9-566BB76E8D8A}"/>
                </a:ext>
              </a:extLst>
            </p:cNvPr>
            <p:cNvCxnSpPr/>
            <p:nvPr/>
          </p:nvCxnSpPr>
          <p:spPr>
            <a:xfrm>
              <a:off x="1247810" y="1367327"/>
              <a:ext cx="229765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BD52E146-2A31-AF5D-87F7-5E8D9AB87C14}"/>
                </a:ext>
              </a:extLst>
            </p:cNvPr>
            <p:cNvCxnSpPr/>
            <p:nvPr/>
          </p:nvCxnSpPr>
          <p:spPr>
            <a:xfrm>
              <a:off x="2643006" y="1301788"/>
              <a:ext cx="229765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38A5347B-0B72-B064-980D-DFDB1A38AA59}"/>
                </a:ext>
              </a:extLst>
            </p:cNvPr>
            <p:cNvCxnSpPr/>
            <p:nvPr/>
          </p:nvCxnSpPr>
          <p:spPr>
            <a:xfrm>
              <a:off x="4014677" y="1952927"/>
              <a:ext cx="229765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B633BF0A-5BD8-B87A-B14F-E5EC7A8EE8FA}"/>
                </a:ext>
              </a:extLst>
            </p:cNvPr>
            <p:cNvCxnSpPr/>
            <p:nvPr/>
          </p:nvCxnSpPr>
          <p:spPr>
            <a:xfrm>
              <a:off x="5276199" y="1289307"/>
              <a:ext cx="288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73F960F-4954-60F7-1BC5-F4C3618F62E4}"/>
                </a:ext>
              </a:extLst>
            </p:cNvPr>
            <p:cNvSpPr txBox="1"/>
            <p:nvPr/>
          </p:nvSpPr>
          <p:spPr>
            <a:xfrm>
              <a:off x="246221" y="2421426"/>
              <a:ext cx="475653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live gate</a:t>
              </a:r>
              <a:endParaRPr lang="en-US" sz="600" b="1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4BE5F01-D4E2-FF2F-431B-33BA219B8BBF}"/>
                </a:ext>
              </a:extLst>
            </p:cNvPr>
            <p:cNvSpPr txBox="1"/>
            <p:nvPr/>
          </p:nvSpPr>
          <p:spPr>
            <a:xfrm>
              <a:off x="2949004" y="2421426"/>
              <a:ext cx="427288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EC</a:t>
              </a:r>
              <a:endParaRPr lang="en-US" sz="600" b="1"/>
            </a:p>
          </p:txBody>
        </p: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BAB41F03-15E8-8B31-35E8-9FBBC56EF3F2}"/>
                </a:ext>
              </a:extLst>
            </p:cNvPr>
            <p:cNvCxnSpPr/>
            <p:nvPr/>
          </p:nvCxnSpPr>
          <p:spPr>
            <a:xfrm>
              <a:off x="6704748" y="1738054"/>
              <a:ext cx="144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5BD7826-C65F-15FC-7050-76BEB9E93CF6}"/>
                </a:ext>
              </a:extLst>
            </p:cNvPr>
            <p:cNvSpPr txBox="1"/>
            <p:nvPr/>
          </p:nvSpPr>
          <p:spPr>
            <a:xfrm>
              <a:off x="1597616" y="2421426"/>
              <a:ext cx="670785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>
                  <a:solidFill>
                    <a:schemeClr val="accent1"/>
                  </a:solidFill>
                </a:rPr>
                <a:t>CD45 negative</a:t>
              </a:r>
              <a:endParaRPr lang="en-US" sz="600" b="1">
                <a:solidFill>
                  <a:schemeClr val="accent1"/>
                </a:solidFill>
              </a:endParaRPr>
            </a:p>
          </p:txBody>
        </p: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DC521C66-1060-F7C5-3306-2840957C0C28}"/>
                </a:ext>
              </a:extLst>
            </p:cNvPr>
            <p:cNvCxnSpPr/>
            <p:nvPr/>
          </p:nvCxnSpPr>
          <p:spPr>
            <a:xfrm>
              <a:off x="2680944" y="3555961"/>
              <a:ext cx="229765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334DC5C-1F8D-35FA-7865-B6FA59FFE0E4}"/>
                </a:ext>
              </a:extLst>
            </p:cNvPr>
            <p:cNvSpPr txBox="1"/>
            <p:nvPr/>
          </p:nvSpPr>
          <p:spPr>
            <a:xfrm>
              <a:off x="2162988" y="2673777"/>
              <a:ext cx="273852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EC</a:t>
              </a:r>
              <a:endParaRPr lang="en-US" sz="60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7CE0705C-D7D7-B00F-322C-FCACA172E5BA}"/>
                </a:ext>
              </a:extLst>
            </p:cNvPr>
            <p:cNvSpPr txBox="1"/>
            <p:nvPr/>
          </p:nvSpPr>
          <p:spPr>
            <a:xfrm>
              <a:off x="3589485" y="3070114"/>
              <a:ext cx="34056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SC</a:t>
              </a:r>
              <a:endParaRPr lang="en-US" sz="60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21BFD26-4FB5-51E5-E08B-2A008E87FA49}"/>
                </a:ext>
              </a:extLst>
            </p:cNvPr>
            <p:cNvSpPr txBox="1"/>
            <p:nvPr/>
          </p:nvSpPr>
          <p:spPr>
            <a:xfrm>
              <a:off x="4320466" y="2421426"/>
              <a:ext cx="49733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MSC</a:t>
              </a:r>
              <a:endParaRPr lang="en-US" sz="600" b="1"/>
            </a:p>
          </p:txBody>
        </p: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D975F30D-EBFC-25AA-4ECB-A286EB74EB71}"/>
                </a:ext>
              </a:extLst>
            </p:cNvPr>
            <p:cNvCxnSpPr/>
            <p:nvPr/>
          </p:nvCxnSpPr>
          <p:spPr>
            <a:xfrm>
              <a:off x="4048002" y="3564082"/>
              <a:ext cx="229765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3E2799E1-17B2-D6C0-4FEC-6E990F79DD12}"/>
                </a:ext>
              </a:extLst>
            </p:cNvPr>
            <p:cNvSpPr/>
            <p:nvPr/>
          </p:nvSpPr>
          <p:spPr>
            <a:xfrm>
              <a:off x="1418926" y="2421426"/>
              <a:ext cx="4195395" cy="1443094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EB6A93E-3272-E971-F8A8-F016F45CA853}"/>
                </a:ext>
              </a:extLst>
            </p:cNvPr>
            <p:cNvSpPr txBox="1"/>
            <p:nvPr/>
          </p:nvSpPr>
          <p:spPr>
            <a:xfrm>
              <a:off x="236135" y="3933296"/>
              <a:ext cx="64743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>
                  <a:solidFill>
                    <a:srgbClr val="7030A0"/>
                  </a:solidFill>
                </a:rPr>
                <a:t>CD45 positive</a:t>
              </a:r>
              <a:endParaRPr lang="en-US" sz="600" b="1">
                <a:solidFill>
                  <a:srgbClr val="7030A0"/>
                </a:solidFill>
              </a:endParaRP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BB0F6706-0609-7DF7-1632-6F60C374C495}"/>
                </a:ext>
              </a:extLst>
            </p:cNvPr>
            <p:cNvSpPr/>
            <p:nvPr/>
          </p:nvSpPr>
          <p:spPr>
            <a:xfrm>
              <a:off x="22847" y="3942739"/>
              <a:ext cx="6829885" cy="4595934"/>
            </a:xfrm>
            <a:prstGeom prst="rect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883A9555-24D8-6CAE-2EE3-AD28998A4902}"/>
                </a:ext>
              </a:extLst>
            </p:cNvPr>
            <p:cNvCxnSpPr/>
            <p:nvPr/>
          </p:nvCxnSpPr>
          <p:spPr>
            <a:xfrm>
              <a:off x="1310044" y="5063093"/>
              <a:ext cx="229765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2D332CC7-C2D1-153F-512F-B47B9BEA2483}"/>
                </a:ext>
              </a:extLst>
            </p:cNvPr>
            <p:cNvCxnSpPr/>
            <p:nvPr/>
          </p:nvCxnSpPr>
          <p:spPr>
            <a:xfrm>
              <a:off x="2543778" y="4365558"/>
              <a:ext cx="252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6461EF6C-C395-8AAE-AFFD-C2A9FA1D3DEB}"/>
                </a:ext>
              </a:extLst>
            </p:cNvPr>
            <p:cNvSpPr txBox="1"/>
            <p:nvPr/>
          </p:nvSpPr>
          <p:spPr>
            <a:xfrm>
              <a:off x="2958480" y="3933296"/>
              <a:ext cx="317215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cDC</a:t>
              </a:r>
              <a:endParaRPr lang="en-US" sz="600" b="1"/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D33A120-81DE-385D-7F68-9EFEEE8A515B}"/>
                </a:ext>
              </a:extLst>
            </p:cNvPr>
            <p:cNvSpPr txBox="1"/>
            <p:nvPr/>
          </p:nvSpPr>
          <p:spPr>
            <a:xfrm>
              <a:off x="4328757" y="3933296"/>
              <a:ext cx="472318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cDC</a:t>
              </a:r>
              <a:endParaRPr lang="en-US" sz="600" b="1"/>
            </a:p>
          </p:txBody>
        </p:sp>
        <p:cxnSp>
          <p:nvCxnSpPr>
            <p:cNvPr id="73" name="Straight Arrow Connector 72">
              <a:extLst>
                <a:ext uri="{FF2B5EF4-FFF2-40B4-BE49-F238E27FC236}">
                  <a16:creationId xmlns:a16="http://schemas.microsoft.com/office/drawing/2014/main" id="{A057B52D-19E1-29F5-D376-0D9143D65BE1}"/>
                </a:ext>
              </a:extLst>
            </p:cNvPr>
            <p:cNvCxnSpPr/>
            <p:nvPr/>
          </p:nvCxnSpPr>
          <p:spPr>
            <a:xfrm>
              <a:off x="5420199" y="5063093"/>
              <a:ext cx="252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F75C3E1-D538-B61B-68AE-370F7A8151A2}"/>
                </a:ext>
              </a:extLst>
            </p:cNvPr>
            <p:cNvSpPr txBox="1"/>
            <p:nvPr/>
          </p:nvSpPr>
          <p:spPr>
            <a:xfrm>
              <a:off x="5682927" y="3933296"/>
              <a:ext cx="732493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neutrophils</a:t>
              </a:r>
              <a:endParaRPr lang="en-US" sz="600" b="1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8340B97E-5946-EA38-5570-87047FEC83C7}"/>
                </a:ext>
              </a:extLst>
            </p:cNvPr>
            <p:cNvSpPr txBox="1"/>
            <p:nvPr/>
          </p:nvSpPr>
          <p:spPr>
            <a:xfrm>
              <a:off x="4387671" y="4581800"/>
              <a:ext cx="564047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neutrophils</a:t>
              </a:r>
              <a:endParaRPr lang="en-US" sz="60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320DEF7D-C068-13BA-5569-49EBDBAECC73}"/>
                </a:ext>
              </a:extLst>
            </p:cNvPr>
            <p:cNvSpPr txBox="1"/>
            <p:nvPr/>
          </p:nvSpPr>
          <p:spPr>
            <a:xfrm>
              <a:off x="281491" y="4087664"/>
              <a:ext cx="55904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eosinophils</a:t>
              </a:r>
              <a:endParaRPr lang="en-US" sz="600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AF46542-45EE-CCE5-E684-5A48802B448D}"/>
                </a:ext>
              </a:extLst>
            </p:cNvPr>
            <p:cNvSpPr txBox="1"/>
            <p:nvPr/>
          </p:nvSpPr>
          <p:spPr>
            <a:xfrm>
              <a:off x="1686979" y="4156073"/>
              <a:ext cx="31888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C</a:t>
              </a:r>
              <a:endParaRPr lang="en-US" sz="600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78F74CA-BE3E-713B-EC5A-7A1C3AB7DA42}"/>
                </a:ext>
              </a:extLst>
            </p:cNvPr>
            <p:cNvSpPr txBox="1"/>
            <p:nvPr/>
          </p:nvSpPr>
          <p:spPr>
            <a:xfrm>
              <a:off x="246221" y="5483636"/>
              <a:ext cx="714148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monocytes</a:t>
              </a:r>
              <a:endParaRPr lang="en-US" sz="600" b="1"/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53C6E709-6351-1432-586E-D7BB0A8DE55C}"/>
                </a:ext>
              </a:extLst>
            </p:cNvPr>
            <p:cNvSpPr txBox="1"/>
            <p:nvPr/>
          </p:nvSpPr>
          <p:spPr>
            <a:xfrm>
              <a:off x="6104052" y="4898304"/>
              <a:ext cx="549037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onocytes</a:t>
              </a:r>
              <a:endParaRPr lang="en-US" sz="600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DC071FBA-1490-35FE-29AF-A49C659DF6D6}"/>
                </a:ext>
              </a:extLst>
            </p:cNvPr>
            <p:cNvSpPr txBox="1"/>
            <p:nvPr/>
          </p:nvSpPr>
          <p:spPr>
            <a:xfrm>
              <a:off x="788798" y="5736324"/>
              <a:ext cx="29720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F</a:t>
              </a:r>
              <a:endParaRPr lang="en-US" sz="600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697C4388-15F4-7640-DC03-06F8ED27110C}"/>
                </a:ext>
              </a:extLst>
            </p:cNvPr>
            <p:cNvSpPr txBox="1"/>
            <p:nvPr/>
          </p:nvSpPr>
          <p:spPr>
            <a:xfrm>
              <a:off x="1617490" y="5826765"/>
              <a:ext cx="300537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1</a:t>
              </a:r>
              <a:endParaRPr lang="en-US" sz="600"/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227AD01-8A63-6018-CF97-F2FB50889C8F}"/>
                </a:ext>
              </a:extLst>
            </p:cNvPr>
            <p:cNvSpPr txBox="1"/>
            <p:nvPr/>
          </p:nvSpPr>
          <p:spPr>
            <a:xfrm>
              <a:off x="1611830" y="5469167"/>
              <a:ext cx="639097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k-SK" sz="600" b="1" dirty="0"/>
                <a:t>macrophages</a:t>
              </a:r>
              <a:endParaRPr lang="en-US" sz="600" b="1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C07F5E5B-A9E5-8B91-23C4-572CF42C5370}"/>
                </a:ext>
              </a:extLst>
            </p:cNvPr>
            <p:cNvSpPr txBox="1"/>
            <p:nvPr/>
          </p:nvSpPr>
          <p:spPr>
            <a:xfrm>
              <a:off x="2122808" y="5834603"/>
              <a:ext cx="372250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1/2</a:t>
              </a:r>
              <a:endParaRPr lang="en-US" sz="600"/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56C2F660-5931-196E-3375-74E05327D548}"/>
                </a:ext>
              </a:extLst>
            </p:cNvPr>
            <p:cNvSpPr txBox="1"/>
            <p:nvPr/>
          </p:nvSpPr>
          <p:spPr>
            <a:xfrm>
              <a:off x="2240587" y="6479621"/>
              <a:ext cx="300537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M2</a:t>
              </a:r>
              <a:endParaRPr lang="en-US" sz="60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1AF25D9-909B-CD52-C571-F622C1991729}"/>
                </a:ext>
              </a:extLst>
            </p:cNvPr>
            <p:cNvSpPr txBox="1"/>
            <p:nvPr/>
          </p:nvSpPr>
          <p:spPr>
            <a:xfrm>
              <a:off x="2960067" y="5479100"/>
              <a:ext cx="794203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 dirty="0"/>
                <a:t>not: </a:t>
              </a:r>
              <a:r>
                <a:rPr lang="sk-SK" sz="600" b="1" dirty="0"/>
                <a:t>macrophages</a:t>
              </a:r>
              <a:endParaRPr lang="en-US" sz="600" b="1" dirty="0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1DD6771-10A3-6040-6CFD-67584059144D}"/>
                </a:ext>
              </a:extLst>
            </p:cNvPr>
            <p:cNvSpPr txBox="1"/>
            <p:nvPr/>
          </p:nvSpPr>
          <p:spPr>
            <a:xfrm>
              <a:off x="3580319" y="6443579"/>
              <a:ext cx="395599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B cells</a:t>
              </a:r>
              <a:endParaRPr lang="en-US" sz="600"/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78C41C48-D413-A713-F2A0-6CAC20847BF4}"/>
                </a:ext>
              </a:extLst>
            </p:cNvPr>
            <p:cNvSpPr txBox="1"/>
            <p:nvPr/>
          </p:nvSpPr>
          <p:spPr>
            <a:xfrm>
              <a:off x="4329131" y="5475013"/>
              <a:ext cx="555708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B cells</a:t>
              </a:r>
              <a:endParaRPr lang="en-US" sz="600" b="1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E66B3440-86C2-4F94-A1B2-5DA00C5A5532}"/>
                </a:ext>
              </a:extLst>
            </p:cNvPr>
            <p:cNvSpPr txBox="1"/>
            <p:nvPr/>
          </p:nvSpPr>
          <p:spPr>
            <a:xfrm>
              <a:off x="4592977" y="5692330"/>
              <a:ext cx="327221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pDC</a:t>
              </a:r>
              <a:endParaRPr lang="en-US" sz="600"/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F1A67074-5DAF-B0A8-83E6-C8414145CEB9}"/>
                </a:ext>
              </a:extLst>
            </p:cNvPr>
            <p:cNvSpPr txBox="1"/>
            <p:nvPr/>
          </p:nvSpPr>
          <p:spPr>
            <a:xfrm>
              <a:off x="5699759" y="5471581"/>
              <a:ext cx="482324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pDC</a:t>
              </a:r>
              <a:endParaRPr lang="en-US" sz="600" b="1"/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B17CD3CF-806A-708D-3C57-658F4FEBA380}"/>
                </a:ext>
              </a:extLst>
            </p:cNvPr>
            <p:cNvSpPr txBox="1"/>
            <p:nvPr/>
          </p:nvSpPr>
          <p:spPr>
            <a:xfrm>
              <a:off x="221566" y="7040840"/>
              <a:ext cx="522352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CD5+DX5-</a:t>
              </a:r>
              <a:endParaRPr lang="en-US" sz="600" b="1"/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6B1ACE78-2354-EA72-BC64-C66F2C4BDCD5}"/>
                </a:ext>
              </a:extLst>
            </p:cNvPr>
            <p:cNvSpPr txBox="1"/>
            <p:nvPr/>
          </p:nvSpPr>
          <p:spPr>
            <a:xfrm>
              <a:off x="1606394" y="7040840"/>
              <a:ext cx="395599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T cells</a:t>
              </a:r>
              <a:endParaRPr lang="en-US" sz="600" b="1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5078C4D9-DB03-6E70-61A9-FAA200A31A6F}"/>
                </a:ext>
              </a:extLst>
            </p:cNvPr>
            <p:cNvSpPr txBox="1"/>
            <p:nvPr/>
          </p:nvSpPr>
          <p:spPr>
            <a:xfrm>
              <a:off x="6117770" y="5801594"/>
              <a:ext cx="32388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NKT</a:t>
              </a:r>
              <a:endParaRPr lang="en-US" sz="600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A122B85E-0DC6-6899-884D-314618B2DB9D}"/>
                </a:ext>
              </a:extLst>
            </p:cNvPr>
            <p:cNvSpPr txBox="1"/>
            <p:nvPr/>
          </p:nvSpPr>
          <p:spPr>
            <a:xfrm>
              <a:off x="6447761" y="6356510"/>
              <a:ext cx="28552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NK</a:t>
              </a:r>
              <a:endParaRPr lang="en-US" sz="600"/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A9DF3B91-9071-7FD3-3982-8BE364DAD6C0}"/>
                </a:ext>
              </a:extLst>
            </p:cNvPr>
            <p:cNvSpPr txBox="1"/>
            <p:nvPr/>
          </p:nvSpPr>
          <p:spPr>
            <a:xfrm>
              <a:off x="1864641" y="7291799"/>
              <a:ext cx="38392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8+ </a:t>
              </a:r>
              <a:endParaRPr lang="en-US" sz="60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392B0B20-CC74-5658-C5DE-C6366D16AB51}"/>
                </a:ext>
              </a:extLst>
            </p:cNvPr>
            <p:cNvSpPr txBox="1"/>
            <p:nvPr/>
          </p:nvSpPr>
          <p:spPr>
            <a:xfrm>
              <a:off x="2242713" y="7580940"/>
              <a:ext cx="383926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CD4+ </a:t>
              </a:r>
              <a:endParaRPr lang="en-US" sz="60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3951658-EF00-9C86-8074-18F943F8021A}"/>
                </a:ext>
              </a:extLst>
            </p:cNvPr>
            <p:cNvSpPr txBox="1"/>
            <p:nvPr/>
          </p:nvSpPr>
          <p:spPr>
            <a:xfrm>
              <a:off x="2959340" y="7040840"/>
              <a:ext cx="585728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CD4+ T cells</a:t>
              </a:r>
              <a:endParaRPr lang="en-US" sz="600" b="1"/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08E181C1-F01F-3230-CE1E-DB784D17A5BC}"/>
                </a:ext>
              </a:extLst>
            </p:cNvPr>
            <p:cNvSpPr txBox="1"/>
            <p:nvPr/>
          </p:nvSpPr>
          <p:spPr>
            <a:xfrm>
              <a:off x="3645139" y="7665385"/>
              <a:ext cx="368915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/>
                <a:t>Tregs</a:t>
              </a:r>
              <a:endParaRPr lang="en-US" sz="600"/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F7988AD-F193-2542-3045-9ECBB5CF0ABF}"/>
                </a:ext>
              </a:extLst>
            </p:cNvPr>
            <p:cNvSpPr txBox="1"/>
            <p:nvPr/>
          </p:nvSpPr>
          <p:spPr>
            <a:xfrm>
              <a:off x="1601973" y="3933296"/>
              <a:ext cx="727490" cy="1911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600" b="1"/>
                <a:t>not: eosinophils</a:t>
              </a:r>
              <a:endParaRPr lang="en-US" sz="600" b="1"/>
            </a:p>
          </p:txBody>
        </p:sp>
        <p:cxnSp>
          <p:nvCxnSpPr>
            <p:cNvPr id="99" name="Straight Arrow Connector 98">
              <a:extLst>
                <a:ext uri="{FF2B5EF4-FFF2-40B4-BE49-F238E27FC236}">
                  <a16:creationId xmlns:a16="http://schemas.microsoft.com/office/drawing/2014/main" id="{F39ACD95-6268-2196-2899-CE81DB7E2279}"/>
                </a:ext>
              </a:extLst>
            </p:cNvPr>
            <p:cNvCxnSpPr/>
            <p:nvPr/>
          </p:nvCxnSpPr>
          <p:spPr>
            <a:xfrm>
              <a:off x="6704084" y="4898366"/>
              <a:ext cx="144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Straight Arrow Connector 99">
              <a:extLst>
                <a:ext uri="{FF2B5EF4-FFF2-40B4-BE49-F238E27FC236}">
                  <a16:creationId xmlns:a16="http://schemas.microsoft.com/office/drawing/2014/main" id="{83C9514C-5786-52FA-FE33-48AF4170C936}"/>
                </a:ext>
              </a:extLst>
            </p:cNvPr>
            <p:cNvCxnSpPr/>
            <p:nvPr/>
          </p:nvCxnSpPr>
          <p:spPr>
            <a:xfrm>
              <a:off x="4048002" y="6648443"/>
              <a:ext cx="252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Arrow Connector 100">
              <a:extLst>
                <a:ext uri="{FF2B5EF4-FFF2-40B4-BE49-F238E27FC236}">
                  <a16:creationId xmlns:a16="http://schemas.microsoft.com/office/drawing/2014/main" id="{4DB76D4A-59F3-2237-1835-E7ACDFE80B06}"/>
                </a:ext>
              </a:extLst>
            </p:cNvPr>
            <p:cNvCxnSpPr/>
            <p:nvPr/>
          </p:nvCxnSpPr>
          <p:spPr>
            <a:xfrm>
              <a:off x="1207138" y="5801594"/>
              <a:ext cx="229765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Straight Arrow Connector 101">
              <a:extLst>
                <a:ext uri="{FF2B5EF4-FFF2-40B4-BE49-F238E27FC236}">
                  <a16:creationId xmlns:a16="http://schemas.microsoft.com/office/drawing/2014/main" id="{A14F70CA-7A0A-D1B7-13F5-FB3D53F7495E}"/>
                </a:ext>
              </a:extLst>
            </p:cNvPr>
            <p:cNvCxnSpPr/>
            <p:nvPr/>
          </p:nvCxnSpPr>
          <p:spPr>
            <a:xfrm>
              <a:off x="5420199" y="6648443"/>
              <a:ext cx="252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Straight Arrow Connector 102">
              <a:extLst>
                <a:ext uri="{FF2B5EF4-FFF2-40B4-BE49-F238E27FC236}">
                  <a16:creationId xmlns:a16="http://schemas.microsoft.com/office/drawing/2014/main" id="{6B7F2C33-B5BB-C020-5A73-85851CBCF2F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607951" y="6656390"/>
              <a:ext cx="432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Straight Arrow Connector 103">
              <a:extLst>
                <a:ext uri="{FF2B5EF4-FFF2-40B4-BE49-F238E27FC236}">
                  <a16:creationId xmlns:a16="http://schemas.microsoft.com/office/drawing/2014/main" id="{73A7B745-D680-57CC-469B-4BA4C718A954}"/>
                </a:ext>
              </a:extLst>
            </p:cNvPr>
            <p:cNvCxnSpPr/>
            <p:nvPr/>
          </p:nvCxnSpPr>
          <p:spPr>
            <a:xfrm>
              <a:off x="1307140" y="7340954"/>
              <a:ext cx="216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Straight Arrow Connector 104">
              <a:extLst>
                <a:ext uri="{FF2B5EF4-FFF2-40B4-BE49-F238E27FC236}">
                  <a16:creationId xmlns:a16="http://schemas.microsoft.com/office/drawing/2014/main" id="{620D9893-B013-26CD-899F-D0008514525E}"/>
                </a:ext>
              </a:extLst>
            </p:cNvPr>
            <p:cNvCxnSpPr/>
            <p:nvPr/>
          </p:nvCxnSpPr>
          <p:spPr>
            <a:xfrm>
              <a:off x="2597618" y="8171437"/>
              <a:ext cx="288000" cy="0"/>
            </a:xfrm>
            <a:prstGeom prst="straightConnector1">
              <a:avLst/>
            </a:prstGeom>
            <a:ln w="952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6" name="TextBox 105">
            <a:extLst>
              <a:ext uri="{FF2B5EF4-FFF2-40B4-BE49-F238E27FC236}">
                <a16:creationId xmlns:a16="http://schemas.microsoft.com/office/drawing/2014/main" id="{B0392647-3E51-37E9-454F-376DA5DEFF1C}"/>
              </a:ext>
            </a:extLst>
          </p:cNvPr>
          <p:cNvSpPr txBox="1"/>
          <p:nvPr/>
        </p:nvSpPr>
        <p:spPr>
          <a:xfrm>
            <a:off x="352862" y="514903"/>
            <a:ext cx="4042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600" b="1" dirty="0"/>
              <a:t>4T1 D5</a:t>
            </a:r>
            <a:endParaRPr lang="en-US" sz="600" b="1" dirty="0"/>
          </a:p>
        </p:txBody>
      </p:sp>
      <p:sp>
        <p:nvSpPr>
          <p:cNvPr id="2" name="TextBox 67">
            <a:extLst>
              <a:ext uri="{FF2B5EF4-FFF2-40B4-BE49-F238E27FC236}">
                <a16:creationId xmlns:a16="http://schemas.microsoft.com/office/drawing/2014/main" id="{8EAB884A-FC97-9F43-C89C-1C527FED4F89}"/>
              </a:ext>
            </a:extLst>
          </p:cNvPr>
          <p:cNvSpPr txBox="1"/>
          <p:nvPr/>
        </p:nvSpPr>
        <p:spPr>
          <a:xfrm>
            <a:off x="-2426" y="-3616"/>
            <a:ext cx="11468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sk-SK" dirty="0"/>
              <a:t>Fig</a:t>
            </a:r>
            <a:r>
              <a:rPr lang="en-US" dirty="0" err="1"/>
              <a:t>ure</a:t>
            </a:r>
            <a:r>
              <a:rPr lang="sk-SK" dirty="0"/>
              <a:t> </a:t>
            </a:r>
            <a:r>
              <a:rPr lang="en-US" dirty="0"/>
              <a:t>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312B3F8-0825-412C-5428-651502549EC6}"/>
              </a:ext>
            </a:extLst>
          </p:cNvPr>
          <p:cNvSpPr txBox="1"/>
          <p:nvPr/>
        </p:nvSpPr>
        <p:spPr>
          <a:xfrm>
            <a:off x="153682" y="8397368"/>
            <a:ext cx="65929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S2</a:t>
            </a:r>
            <a:endParaRPr lang="en-US" sz="1000" dirty="0"/>
          </a:p>
          <a:p>
            <a:pPr algn="just"/>
            <a:r>
              <a:rPr lang="en-US" sz="1000" dirty="0"/>
              <a:t>Gating strategy for flow cytometry.</a:t>
            </a:r>
          </a:p>
          <a:p>
            <a:pPr algn="just"/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827927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6199</TotalTime>
  <Words>124</Words>
  <Application>Microsoft Office PowerPoint</Application>
  <PresentationFormat>A4 Paper (210x297 mm)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</dc:creator>
  <cp:lastModifiedBy>Nissley, Elyse</cp:lastModifiedBy>
  <cp:revision>875</cp:revision>
  <cp:lastPrinted>2024-07-30T07:25:05Z</cp:lastPrinted>
  <dcterms:created xsi:type="dcterms:W3CDTF">2023-02-23T11:46:10Z</dcterms:created>
  <dcterms:modified xsi:type="dcterms:W3CDTF">2025-11-05T19:30:11Z</dcterms:modified>
</cp:coreProperties>
</file>